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70" r:id="rId4"/>
    <p:sldId id="262" r:id="rId5"/>
    <p:sldId id="271" r:id="rId6"/>
    <p:sldId id="272" r:id="rId7"/>
    <p:sldId id="273" r:id="rId8"/>
    <p:sldId id="274" r:id="rId9"/>
    <p:sldId id="275" r:id="rId10"/>
    <p:sldId id="276" r:id="rId11"/>
    <p:sldId id="277" r:id="rId12"/>
    <p:sldId id="278" r:id="rId13"/>
    <p:sldId id="269" r:id="rId14"/>
    <p:sldId id="279" r:id="rId15"/>
    <p:sldId id="28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8" y="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F74B9-AA1A-4043-9A4E-9C872A38E8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10375A-9A61-48E2-BE08-C02510D039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EFD86-7C8B-4C12-968D-112067070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37B3B-8DAD-403A-B1FC-1A6C4647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0E7742-6324-4D3D-8899-FA92363CE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7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F4F9-AD79-41E3-B4E1-2FAB9E4A9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390509-1307-477F-B3D8-1C2084D90C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002ED-032B-49F8-960C-DAB00F2A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0023B-B926-434A-86C6-27CF4A2DE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E89CB-641E-4C11-A886-EB965E393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274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961C6C-52C9-43E5-A50B-64E587AA3C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D15889-C83A-4714-9D49-604B335D0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271BA-1D57-46FC-BC07-BC79689E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9A64A-DB2A-48AA-B93B-F16ED01C6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8185F-221A-436E-AE09-D78009D70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6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22BC3-6630-47A1-BE47-623930EFE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4AC7D-2747-4E92-AE9F-30FEBC9803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E61DB-161C-45AD-A035-34D0BF4D2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B58412-EC3E-4500-8C29-964D1BECE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814CF-7E70-4529-A78C-69360A428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3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C531D-23FA-43D6-B9F7-C65CA9EA2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C11F1D-CBA3-44D2-B011-143A62841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F8116-57DF-415E-9457-92E8E11C8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F6FA3-E8A8-427A-B974-E9743C4FB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1D5E5-A423-463C-A2D8-8338F5518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120F9-96C7-4197-9F54-D7BE8AD6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E700E-46B7-461D-A74C-42E52F469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237CBD-3533-45A1-97D7-CCFF48C43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611CF-9871-48C2-B15C-7E06D5B2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F8038C-E0DC-4EEA-BA46-A6476208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32BA0-0038-474F-A341-A3794AB3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68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455A6-2E54-466C-A38C-7F7EFCA1F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044DDB-168E-4DE9-9E22-891BC4471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58B725-D7E5-4E1E-BCB1-356C1FBB70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3E7CB6-27FA-4482-98E0-49CF388A3A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C665C2-EF65-4057-A97E-393654AB60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85DFD7-0F8C-42C3-8EBE-7510361F6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968848-B6E7-4099-A881-16A2D7D62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72C74F-43AF-42BF-94E3-157FB6C00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15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82530-DBB8-4ABC-913E-B318316E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5BCA75-D234-4F02-896F-174A4C6F9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E3B34C-64BB-4163-89FF-4FA9F271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14758C-BBC1-4126-A681-B55BE1D71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79025A-EF2B-4DDE-B880-811879A43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C924ED-CD40-4A3B-ACE1-5764C12D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7672A-6F9A-48CE-A80C-97DF5662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4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496A3-FF45-498B-9755-34526CCFF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65E3FD-E214-403D-8A8F-1C460C4C38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94892C-3164-48DF-B72A-3A325720C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A9094-C13B-4507-B2BD-9073144DB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D6999-7C00-47F5-BEBD-208F6B524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FF8C49-C868-4C20-9D4B-1E630A0C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8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173DB-BED6-42EF-B44E-487CA1391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9F2E6D-CC8A-4AB7-8CF6-DAC186FC84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DF9B87-E0B0-4F81-92D5-6A9083DE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E38E9C-D3D7-4B59-83E3-93D6DC392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3B52F-236A-416B-932F-96745C7E3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C0FEFE-C823-4397-AC19-8A4DB030D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8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8E09C2-07DF-40B1-B680-F84B64862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584A52-1671-43D5-A749-B5B4E4BE5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ACE89-8CB3-45E5-86F3-2B6954498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0FED-96BB-4C58-BAE9-FF799B3887DF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9781A-0198-4235-BEA2-6962E70E0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5650F-8EE0-40B0-906B-189AF171A8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273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hyperlink" Target="https://upload.wikimedia.org/wikipedia/commons/b/bc/Normal_PA_chest_x-ray_(5414485536).jpg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FFEE01-BF6D-43D0-ABE2-71C7579250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CBC 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marR="0" indent="0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White blood count    	23.4 x1000/mm3 </a:t>
            </a:r>
            <a:r>
              <a:rPr lang="en-US" sz="3600" b="1" dirty="0">
                <a:solidFill>
                  <a:srgbClr val="FF0000"/>
                </a:solidFill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Hemoglobin 	     		6.5 g/dL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Hematocrit      			18.0%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latelet 	     			45 x1000/mm3  </a:t>
            </a:r>
            <a:r>
              <a:rPr lang="en-US" sz="3600" b="1" dirty="0">
                <a:solidFill>
                  <a:srgbClr val="FF0000"/>
                </a:solidFill>
                <a:ea typeface="Times New Roman" panose="02020603050405020304" pitchFamily="18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ands    				17%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3600" b="1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7786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Lactate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5.0 mmol/L </a:t>
            </a:r>
            <a:r>
              <a:rPr lang="en-US" sz="3600" b="1" dirty="0">
                <a:solidFill>
                  <a:srgbClr val="FF0000"/>
                </a:solidFill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3293570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Venous Blood Gas</a:t>
            </a: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H:         7.22 </a:t>
            </a:r>
            <a:r>
              <a:rPr lang="en-US" sz="36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C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25 mmHg </a:t>
            </a:r>
            <a:r>
              <a:rPr lang="en-US" sz="36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   63 mmHg</a:t>
            </a: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HC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14 </a:t>
            </a:r>
            <a:r>
              <a:rPr lang="en-US" sz="3600" dirty="0" err="1">
                <a:effectLst/>
                <a:ea typeface="Calibri" panose="020F0502020204030204" pitchFamily="34" charset="0"/>
              </a:rPr>
              <a:t>mEq</a:t>
            </a:r>
            <a:r>
              <a:rPr lang="en-US" sz="3600" dirty="0">
                <a:effectLst/>
                <a:ea typeface="Calibri" panose="020F0502020204030204" pitchFamily="34" charset="0"/>
              </a:rPr>
              <a:t>/L </a:t>
            </a:r>
            <a:r>
              <a:rPr lang="en-US" sz="3600" b="1" dirty="0">
                <a:solidFill>
                  <a:srgbClr val="FF0000"/>
                </a:solidFill>
                <a:effectLst/>
                <a:ea typeface="Calibri" panose="020F0502020204030204" pitchFamily="34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 Saturation: 96% on room air</a:t>
            </a:r>
          </a:p>
        </p:txBody>
      </p:sp>
    </p:spTree>
    <p:extLst>
      <p:ext uri="{BB962C8B-B14F-4D97-AF65-F5344CB8AC3E}">
        <p14:creationId xmlns:p14="http://schemas.microsoft.com/office/powerpoint/2010/main" val="38876040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Urinalysis</a:t>
            </a: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Leukocyte esterase: negativ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Nitrites: negativ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lood: large </a:t>
            </a:r>
            <a:r>
              <a:rPr lang="en-US" sz="24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rotein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Ketones: 2+ </a:t>
            </a:r>
            <a:r>
              <a:rPr lang="en-US" sz="24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Glucose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olor: brown </a:t>
            </a:r>
            <a:r>
              <a:rPr lang="en-US" sz="2400" b="1" dirty="0">
                <a:solidFill>
                  <a:srgbClr val="FF0000"/>
                </a:solidFill>
                <a:ea typeface="Times New Roman" panose="02020603050405020304" pitchFamily="18" charset="0"/>
              </a:rPr>
              <a:t>(!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WBC: 0-5 WBCs/high powered field (HPF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BC: &gt;50 RBCs/HPF </a:t>
            </a:r>
            <a:r>
              <a:rPr lang="en-US" sz="24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quamous epithelial cells: 10-15 cells/HPF </a:t>
            </a:r>
            <a:r>
              <a:rPr lang="en-US" sz="24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pecific gravity: 1.015</a:t>
            </a:r>
            <a:endParaRPr lang="en-US" sz="24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9826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1600px-Sinustachy">
            <a:extLst>
              <a:ext uri="{FF2B5EF4-FFF2-40B4-BE49-F238E27FC236}">
                <a16:creationId xmlns:a16="http://schemas.microsoft.com/office/drawing/2014/main" id="{B455B794-F371-AE91-931D-9674A0EB2A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333" y="479425"/>
            <a:ext cx="11585334" cy="5899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002806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3BF464-BFC0-98E4-342D-18036D3365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88" y="814069"/>
            <a:ext cx="11861424" cy="50104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8069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hlinkClick r:id="rId2"/>
            <a:extLst>
              <a:ext uri="{FF2B5EF4-FFF2-40B4-BE49-F238E27FC236}">
                <a16:creationId xmlns:a16="http://schemas.microsoft.com/office/drawing/2014/main" id="{F364AF3E-1FAF-6FFB-2F0A-CE7A8CD452B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9202" y="0"/>
            <a:ext cx="9814560" cy="736125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3584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72924" y="544010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3200" b="1" dirty="0"/>
              <a:t>BMP </a:t>
            </a:r>
            <a:endParaRPr lang="en-US" sz="3200" dirty="0"/>
          </a:p>
          <a:p>
            <a:pPr marL="0" indent="0">
              <a:buNone/>
            </a:pPr>
            <a:r>
              <a:rPr lang="en-US" sz="3200" dirty="0"/>
              <a:t> </a:t>
            </a: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odium     		 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38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Eq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/L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hloride      		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99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Eq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/L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otassium  			4.5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Eq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/L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icarbonate 		 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4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Eq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/L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L)</a:t>
            </a:r>
            <a:r>
              <a:rPr lang="en-US" sz="3600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  </a:t>
            </a:r>
            <a:endParaRPr lang="en-US" sz="3600" dirty="0">
              <a:solidFill>
                <a:srgbClr val="FF0000"/>
              </a:solidFill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lood Urea Nitrogen       36 mg/dL  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reatinine 		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.2 mg/dL 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Glucose     		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110 mg/dL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alcium   			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        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8.0 mg/dL </a:t>
            </a:r>
            <a:endParaRPr lang="en-US" sz="36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5273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0E11AA-8243-47D5-A69D-5F4D82147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latin typeface="+mn-lt"/>
              </a:rPr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305939-30E0-443C-A9C3-28DBEEB3A6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T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ili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	2.8 mg/dL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D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ili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	0.2 mg/d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ST 		30 units/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T 		40 units/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bumin   3.0 g/d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k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Phos 	100 units/L</a:t>
            </a:r>
            <a:endParaRPr lang="en-US" sz="36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9961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PTT</a:t>
            </a:r>
            <a:endParaRPr lang="en-US" sz="3600" dirty="0"/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8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9 sec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993677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PT/INR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20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sec/1.7</a:t>
            </a:r>
            <a:r>
              <a:rPr lang="en-US" sz="3600" dirty="0">
                <a:ea typeface="Calibri" panose="020F0502020204030204" pitchFamily="34" charset="0"/>
              </a:rPr>
              <a:t>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69304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D-dimer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.7 ug/mL</a:t>
            </a:r>
            <a:r>
              <a:rPr lang="en-US" sz="3600" dirty="0">
                <a:ea typeface="Calibri" panose="020F0502020204030204" pitchFamily="34" charset="0"/>
              </a:rPr>
              <a:t>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H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0024698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Fibrinogen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90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m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g/dL</a:t>
            </a:r>
            <a:r>
              <a:rPr lang="en-US" sz="3600" dirty="0">
                <a:ea typeface="Calibri" panose="020F0502020204030204" pitchFamily="34" charset="0"/>
              </a:rPr>
              <a:t>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L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0353200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 err="1"/>
              <a:t>hCG</a:t>
            </a:r>
            <a:r>
              <a:rPr lang="en-US" sz="3600" b="1" dirty="0"/>
              <a:t> qualitative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a typeface="Calibri" panose="020F0502020204030204" pitchFamily="34" charset="0"/>
              </a:rPr>
              <a:t>positive</a:t>
            </a:r>
            <a:r>
              <a:rPr lang="en-US" sz="3600" dirty="0">
                <a:ea typeface="Calibri" panose="020F0502020204030204" pitchFamily="34" charset="0"/>
              </a:rPr>
              <a:t> </a:t>
            </a:r>
            <a:r>
              <a:rPr lang="en-US" sz="3600" b="1" dirty="0">
                <a:solidFill>
                  <a:srgbClr val="FF0000"/>
                </a:solidFill>
                <a:effectLst/>
                <a:ea typeface="Times New Roman" panose="02020603050405020304" pitchFamily="18" charset="0"/>
              </a:rPr>
              <a:t>(!)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38683166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 err="1"/>
              <a:t>hCG</a:t>
            </a:r>
            <a:r>
              <a:rPr lang="en-US" sz="3600" b="1" dirty="0"/>
              <a:t> quantitative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40,380 </a:t>
            </a:r>
            <a:r>
              <a:rPr lang="en-US" sz="36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IU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/m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3952424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326</Words>
  <Application>Microsoft Office PowerPoint</Application>
  <PresentationFormat>Widescreen</PresentationFormat>
  <Paragraphs>58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Hepatic Function Pane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Jennifer Yee</cp:lastModifiedBy>
  <cp:revision>59</cp:revision>
  <dcterms:created xsi:type="dcterms:W3CDTF">2017-07-27T19:07:38Z</dcterms:created>
  <dcterms:modified xsi:type="dcterms:W3CDTF">2023-11-20T13:17:06Z</dcterms:modified>
</cp:coreProperties>
</file>